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69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3" autoAdjust="0"/>
    <p:restoredTop sz="94660"/>
  </p:normalViewPr>
  <p:slideViewPr>
    <p:cSldViewPr snapToGrid="0">
      <p:cViewPr>
        <p:scale>
          <a:sx n="75" d="100"/>
          <a:sy n="75" d="100"/>
        </p:scale>
        <p:origin x="1958" y="-37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6F1EE4-0097-4870-A63F-05201228076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488745-3298-461C-BAB5-7732D4D3C3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310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892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1155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085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961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3859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0908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460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7910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7968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2802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722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8491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>
            <a:extLst>
              <a:ext uri="{FF2B5EF4-FFF2-40B4-BE49-F238E27FC236}">
                <a16:creationId xmlns:a16="http://schemas.microsoft.com/office/drawing/2014/main" id="{D5EDD063-5F0A-4CCB-8801-F619063ED997}"/>
              </a:ext>
            </a:extLst>
          </p:cNvPr>
          <p:cNvGrpSpPr/>
          <p:nvPr/>
        </p:nvGrpSpPr>
        <p:grpSpPr>
          <a:xfrm>
            <a:off x="602957" y="453841"/>
            <a:ext cx="5284002" cy="3408461"/>
            <a:chOff x="602957" y="453841"/>
            <a:chExt cx="5284002" cy="3408461"/>
          </a:xfrm>
        </p:grpSpPr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418FE734-4667-4A16-97E6-8C1C3A3022B6}"/>
                </a:ext>
              </a:extLst>
            </p:cNvPr>
            <p:cNvSpPr txBox="1"/>
            <p:nvPr/>
          </p:nvSpPr>
          <p:spPr>
            <a:xfrm>
              <a:off x="602957" y="523551"/>
              <a:ext cx="216780" cy="28676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04FF12FA-9289-4E63-B129-86CEBA99BEC3}"/>
                </a:ext>
              </a:extLst>
            </p:cNvPr>
            <p:cNvSpPr txBox="1"/>
            <p:nvPr/>
          </p:nvSpPr>
          <p:spPr>
            <a:xfrm>
              <a:off x="602957" y="2323880"/>
              <a:ext cx="216780" cy="28676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387F77AE-D188-4FDB-B17F-E269BF386A02}"/>
                </a:ext>
              </a:extLst>
            </p:cNvPr>
            <p:cNvGrpSpPr/>
            <p:nvPr/>
          </p:nvGrpSpPr>
          <p:grpSpPr>
            <a:xfrm>
              <a:off x="1241911" y="453841"/>
              <a:ext cx="4645048" cy="3408461"/>
              <a:chOff x="1241911" y="453841"/>
              <a:chExt cx="4645048" cy="3408461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CE371A57-BE0E-468F-8AE2-4D0B8775DBE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784096" y="2118156"/>
                <a:ext cx="3972560" cy="1744146"/>
              </a:xfrm>
              <a:prstGeom prst="rect">
                <a:avLst/>
              </a:prstGeom>
            </p:spPr>
          </p:pic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id="{87E79DE9-5B8C-45F0-9A6D-17BDF774452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241911" y="453841"/>
                <a:ext cx="4645048" cy="1825190"/>
              </a:xfrm>
              <a:prstGeom prst="rect">
                <a:avLst/>
              </a:prstGeom>
            </p:spPr>
          </p:pic>
        </p:grp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0853E586-C933-447B-8AEC-D2C1B9E697AA}"/>
              </a:ext>
            </a:extLst>
          </p:cNvPr>
          <p:cNvGrpSpPr/>
          <p:nvPr/>
        </p:nvGrpSpPr>
        <p:grpSpPr>
          <a:xfrm>
            <a:off x="602957" y="3792852"/>
            <a:ext cx="5814566" cy="4435588"/>
            <a:chOff x="602957" y="3885452"/>
            <a:chExt cx="5814566" cy="4435588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950BE8A2-3DCA-4827-98BE-D2086D7927A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62265" y="6059216"/>
              <a:ext cx="5565675" cy="2261824"/>
            </a:xfrm>
            <a:prstGeom prst="rect">
              <a:avLst/>
            </a:prstGeom>
          </p:spPr>
        </p:pic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443F22B7-4799-4BC0-BA72-DCD5EEA0889C}"/>
                </a:ext>
              </a:extLst>
            </p:cNvPr>
            <p:cNvSpPr txBox="1"/>
            <p:nvPr/>
          </p:nvSpPr>
          <p:spPr>
            <a:xfrm>
              <a:off x="602957" y="3982634"/>
              <a:ext cx="216780" cy="2154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FF1AA531-8179-45B2-871D-AA213A1F4779}"/>
                </a:ext>
              </a:extLst>
            </p:cNvPr>
            <p:cNvSpPr txBox="1"/>
            <p:nvPr/>
          </p:nvSpPr>
          <p:spPr>
            <a:xfrm>
              <a:off x="602957" y="5952510"/>
              <a:ext cx="216780" cy="2154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BB74692C-E226-4B8D-9F97-30AA0C3F87F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11347" y="3885452"/>
              <a:ext cx="5706176" cy="2305652"/>
            </a:xfrm>
            <a:prstGeom prst="rect">
              <a:avLst/>
            </a:prstGeom>
          </p:spPr>
        </p:pic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E2CA1B78-B5C9-4658-A2F3-3D8781F7B77D}"/>
              </a:ext>
            </a:extLst>
          </p:cNvPr>
          <p:cNvSpPr txBox="1"/>
          <p:nvPr/>
        </p:nvSpPr>
        <p:spPr>
          <a:xfrm>
            <a:off x="851848" y="8098617"/>
            <a:ext cx="5565675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Low"/>
            <a:r>
              <a:rPr lang="en-US" sz="1000" b="1" dirty="0">
                <a:solidFill>
                  <a:srgbClr val="0E101A"/>
                </a:solidFill>
                <a:effectLst/>
              </a:rPr>
              <a:t>Supplementary Figure 4 | Genome targeting efficiency (%).</a:t>
            </a:r>
            <a:r>
              <a:rPr lang="en-US" sz="1000" dirty="0"/>
              <a:t> </a:t>
            </a:r>
            <a:r>
              <a:rPr lang="en-US" sz="1000" b="1" dirty="0">
                <a:solidFill>
                  <a:srgbClr val="0E101A"/>
                </a:solidFill>
                <a:effectLst/>
              </a:rPr>
              <a:t>a</a:t>
            </a:r>
            <a:r>
              <a:rPr lang="en-US" sz="1000" dirty="0"/>
              <a:t>, T7E1 has been applied to assess </a:t>
            </a:r>
            <a:r>
              <a:rPr lang="en-US" sz="1000" i="1" dirty="0"/>
              <a:t>MKK2</a:t>
            </a:r>
            <a:r>
              <a:rPr lang="en-US" sz="1000" dirty="0"/>
              <a:t> genome targeting efficiency via all recovered events. (-) means untreated by T7E1, and (+) means treated by T7E1. Extracted genomic DNA from WT was used as a negative control for T7E1 treatments, and extracted plasmid from </a:t>
            </a:r>
            <a:r>
              <a:rPr lang="en-US" sz="1000" i="1" dirty="0">
                <a:solidFill>
                  <a:srgbClr val="0E101A"/>
                </a:solidFill>
                <a:effectLst/>
              </a:rPr>
              <a:t>E. coli </a:t>
            </a:r>
            <a:r>
              <a:rPr lang="en-US" sz="1000" dirty="0"/>
              <a:t>was used as a positive integrated control (PIC) for edited events. To control PCR affected by unexpected pollution, T7E1 has been applied with no genomic DNA as the negative control test (NCT). </a:t>
            </a:r>
            <a:r>
              <a:rPr lang="en-US" sz="1000" dirty="0">
                <a:highlight>
                  <a:srgbClr val="FFFF00"/>
                </a:highlight>
              </a:rPr>
              <a:t>Yellow dashed boxes are exhibiting mismatched heteroduplexes affected by Cas9 cleavage.</a:t>
            </a:r>
            <a:r>
              <a:rPr lang="en-US" sz="1000" dirty="0"/>
              <a:t> </a:t>
            </a:r>
            <a:r>
              <a:rPr lang="en-US" sz="1000" b="1" dirty="0">
                <a:solidFill>
                  <a:srgbClr val="0E101A"/>
                </a:solidFill>
                <a:effectLst/>
              </a:rPr>
              <a:t>b</a:t>
            </a:r>
            <a:r>
              <a:rPr lang="en-US" sz="1000" dirty="0"/>
              <a:t>, Genome targeting efficiency (%) via density measurements by ImageJ ver2. </a:t>
            </a:r>
            <a:r>
              <a:rPr lang="en-US" sz="1000" b="1" dirty="0"/>
              <a:t>c</a:t>
            </a:r>
            <a:r>
              <a:rPr lang="en-US" sz="1000" dirty="0"/>
              <a:t>, T7E1 has been applied to assess </a:t>
            </a:r>
            <a:r>
              <a:rPr lang="en-US" sz="1000" i="1" dirty="0"/>
              <a:t>XRCC4</a:t>
            </a:r>
            <a:r>
              <a:rPr lang="en-US" sz="1000" dirty="0"/>
              <a:t> genome targeting efficiency via </a:t>
            </a:r>
            <a:r>
              <a:rPr lang="en-US" sz="1000" dirty="0" err="1"/>
              <a:t>ExV</a:t>
            </a:r>
            <a:r>
              <a:rPr lang="en-US" sz="1000" dirty="0"/>
              <a:t> events. (-) means untreated by T7E1, and (+) means treated by T7E1. </a:t>
            </a:r>
            <a:r>
              <a:rPr lang="en-US" sz="1000" b="1" dirty="0"/>
              <a:t>d</a:t>
            </a:r>
            <a:r>
              <a:rPr lang="en-US" sz="1000" dirty="0"/>
              <a:t>, Genome targeting efficiency (%) via density measurements by ImageJ ver2.</a:t>
            </a:r>
            <a:endParaRPr lang="en-US" sz="1000" dirty="0">
              <a:solidFill>
                <a:srgbClr val="0E101A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24870967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6</TotalTime>
  <Words>169</Words>
  <Application>Microsoft Office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vahedi Ali</dc:creator>
  <cp:lastModifiedBy>Movahedi Ali</cp:lastModifiedBy>
  <cp:revision>9</cp:revision>
  <dcterms:created xsi:type="dcterms:W3CDTF">2022-05-10T05:11:22Z</dcterms:created>
  <dcterms:modified xsi:type="dcterms:W3CDTF">2022-05-16T07:40:48Z</dcterms:modified>
</cp:coreProperties>
</file>